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1" d="100"/>
          <a:sy n="81" d="100"/>
        </p:scale>
        <p:origin x="725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B929355-06A8-4C28-9A74-D1CCFA1F3FA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D6731C2-F0AC-4EFD-8C42-9C39FE98F43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04F8E90-76EC-44D0-B81A-20A7BD8479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AE4B84-DB32-45C4-AD77-CAB9D30DD579}" type="datetimeFigureOut">
              <a:rPr lang="en-US" smtClean="0"/>
              <a:t>4/27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484C578-4B56-4A27-84DE-822E7B1C65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6BD48A2-BFA3-4267-89F9-DF9FBC6244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421A59-A5B3-47D0-8969-9217A2A440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69189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451337-BD21-490D-ACA9-F76DEE3F138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6105608-DCE1-402C-A0AD-BB6D47FFED4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898E27A-C89A-4D91-B416-1BC96DA71C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AE4B84-DB32-45C4-AD77-CAB9D30DD579}" type="datetimeFigureOut">
              <a:rPr lang="en-US" smtClean="0"/>
              <a:t>4/27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A273708-467C-44BD-99F2-70CB89E5F5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5A7F6F9-0E18-4524-9C6F-9B5F73DEA1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421A59-A5B3-47D0-8969-9217A2A440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94369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E00EB34-0358-4401-A63C-F909EE21D5E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06B1DA4-C138-496A-8382-C7F73542D6B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B01F924-8E1B-4235-89AB-D2F8D9E799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AE4B84-DB32-45C4-AD77-CAB9D30DD579}" type="datetimeFigureOut">
              <a:rPr lang="en-US" smtClean="0"/>
              <a:t>4/27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2BD6BBE-00D8-448D-9DCD-32E9049392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DFA522C-088E-47CE-9A67-F2BE67540F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421A59-A5B3-47D0-8969-9217A2A440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98990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0DE04A-BE6C-449F-AD78-734FEF84256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484FAD5-8910-41B1-844B-E727B6C8495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97BA816-FF52-4312-AD75-791F6DCBEB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AE4B84-DB32-45C4-AD77-CAB9D30DD579}" type="datetimeFigureOut">
              <a:rPr lang="en-US" smtClean="0"/>
              <a:t>4/27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8B865D5-6C4E-4D28-BB2C-4D7162D746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BCC5C34-28CC-4812-A7E5-05B4D61DC4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421A59-A5B3-47D0-8969-9217A2A440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75995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55371F7-F833-4357-A884-6FC79F4FFF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45E322C-A704-41FF-8DEC-D29ADDACABA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2076901-5960-4A71-9819-7BE1EE19AB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AE4B84-DB32-45C4-AD77-CAB9D30DD579}" type="datetimeFigureOut">
              <a:rPr lang="en-US" smtClean="0"/>
              <a:t>4/27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09E4D1F-9ACD-4411-8A39-1070253682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D8860BD-5059-4E2C-9F82-68FF6AFF8B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421A59-A5B3-47D0-8969-9217A2A440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32248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F45737-3396-4130-8C59-259ADECCEB0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154CF90-C7FA-4911-8DE5-446B7FA9555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2814926-CB5C-4551-9451-B6D9184A2B6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E409AD5-AE67-4FBA-9C1C-93845B1598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AE4B84-DB32-45C4-AD77-CAB9D30DD579}" type="datetimeFigureOut">
              <a:rPr lang="en-US" smtClean="0"/>
              <a:t>4/27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3D9003C-FB82-484C-815E-0DFEB9F2B4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72B53C4-7FE9-429C-A03D-890F88982C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421A59-A5B3-47D0-8969-9217A2A440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79291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B2240B-FDCA-489A-87C6-C4321725D0C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D0CA20B-ABE0-4E91-A9BC-C9C288E92A2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10AEBED-D0FB-4A39-BA77-F0783FF0ABE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0ABA76B-7C36-4A87-A765-C1C629F0A82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24C64BA-ACA7-48EA-96C3-1C50642ACBA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758D540-53FB-4634-B1E8-36414DA52D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AE4B84-DB32-45C4-AD77-CAB9D30DD579}" type="datetimeFigureOut">
              <a:rPr lang="en-US" smtClean="0"/>
              <a:t>4/27/2026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A214C7A-23C4-487C-97EF-B9E783F16D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95CB004-F9C0-4C6F-AD32-0F53C879D4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421A59-A5B3-47D0-8969-9217A2A440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24135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37F7D2-845A-425C-B775-328845FF0B0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67310D3-1C61-4086-86C9-5ACD785447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AE4B84-DB32-45C4-AD77-CAB9D30DD579}" type="datetimeFigureOut">
              <a:rPr lang="en-US" smtClean="0"/>
              <a:t>4/27/2026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B500E77-A185-4495-932B-7B79F03903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CC19551-38C9-435A-8EE9-F40AEB3B97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421A59-A5B3-47D0-8969-9217A2A440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37335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045E709-7EE0-4AA2-8F9D-23FE2A81AF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AE4B84-DB32-45C4-AD77-CAB9D30DD579}" type="datetimeFigureOut">
              <a:rPr lang="en-US" smtClean="0"/>
              <a:t>4/27/2026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63B9D0D-615C-494B-9FB8-2CB3320B82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A3AE959-3300-47F0-8CA3-226DC0665D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421A59-A5B3-47D0-8969-9217A2A440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85269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66AF40-E53A-4007-85F4-42BF6E0D41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EC97537-1F4D-4762-A267-CD8890EB276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9DD7A78-94C7-4BD6-B56B-3FCE44CA519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9055452-8003-49E9-A24F-70813B76C2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AE4B84-DB32-45C4-AD77-CAB9D30DD579}" type="datetimeFigureOut">
              <a:rPr lang="en-US" smtClean="0"/>
              <a:t>4/27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F0DE7E0-CBE5-4D0F-843F-AD2818D6CF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96711CB-97FC-4BD4-B723-92618CE3AD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421A59-A5B3-47D0-8969-9217A2A440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61275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5ACF994-8541-4AED-AD34-9DD0240149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CBE0F14-D4EF-40DA-AE97-A703084268F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BE63903-F715-4EF3-9D73-8E71F05BD68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8E70B9E-1208-44E4-B639-1A537A4A15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AE4B84-DB32-45C4-AD77-CAB9D30DD579}" type="datetimeFigureOut">
              <a:rPr lang="en-US" smtClean="0"/>
              <a:t>4/27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8A0C261-E751-423C-B26C-E12D11EE34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2788BD1-8735-4E45-A6B3-EC5D3D8063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421A59-A5B3-47D0-8969-9217A2A440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84400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AFA33AA-0A89-49C7-AFBF-DA3C4D20C6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770B739-D6E3-4D6B-AB3C-BA9916290CD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D0E7982-C677-44A4-94CD-65D58724FE7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AE4B84-DB32-45C4-AD77-CAB9D30DD579}" type="datetimeFigureOut">
              <a:rPr lang="en-US" smtClean="0"/>
              <a:t>4/27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CD1DA72-9705-4506-A6D9-455A85418ED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3D1A439-E645-4BD1-BBFD-A2DE7D560FD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421A59-A5B3-47D0-8969-9217A2A440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77555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D0139C92-E181-4F6B-A482-657BE6FCA6FD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010" t="2612" r="18524" b="20963"/>
          <a:stretch/>
        </p:blipFill>
        <p:spPr>
          <a:xfrm>
            <a:off x="2695190" y="98086"/>
            <a:ext cx="6801619" cy="5782415"/>
          </a:xfrm>
          <a:prstGeom prst="ellipse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9B858AFA-EA4E-4B5C-9F02-F2782ADFE27A}"/>
              </a:ext>
            </a:extLst>
          </p:cNvPr>
          <p:cNvSpPr/>
          <p:nvPr/>
        </p:nvSpPr>
        <p:spPr>
          <a:xfrm>
            <a:off x="1232279" y="5880501"/>
            <a:ext cx="9727440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3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miRNA targeting networks of </a:t>
            </a:r>
            <a:r>
              <a:rPr lang="en-US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oARF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s. Blue and orange boxes denote miRNAs and their target </a:t>
            </a:r>
            <a:r>
              <a:rPr lang="en-US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oARF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s in 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</a:t>
            </a:r>
            <a:r>
              <a:rPr lang="en-US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ficinarum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-Purple, respectively. All predicted miRNA-ARF target pairs are listed in </a:t>
            </a:r>
            <a:r>
              <a:rPr lang="en-US" sz="14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S3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20889070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42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hmad Ali</dc:creator>
  <cp:lastModifiedBy>Ahmad Ali</cp:lastModifiedBy>
  <cp:revision>6</cp:revision>
  <dcterms:created xsi:type="dcterms:W3CDTF">2026-04-02T03:54:03Z</dcterms:created>
  <dcterms:modified xsi:type="dcterms:W3CDTF">2026-04-27T03:26:45Z</dcterms:modified>
</cp:coreProperties>
</file>